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86A322-3A3B-4098-9785-2B6518202FA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0A8542-EEC6-4422-BD9D-82786433556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8998CB-7539-4538-BA8F-C4BE8DAC255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BB8467-09E1-49DA-8127-2A9A72CDC89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8942D1-4640-445D-BDEB-D227396CA4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059FBF-8B8E-4757-B60E-C543EB5087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6AFDF5-95B9-484A-AA90-255FDCED5CB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ECB602-DDFB-480E-AD7A-519C87BF83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00"/>
              </a:spcBef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80C8A7-0D21-46A0-8908-CAD4678377D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79BEF8-F558-4EA6-A382-D32EB16571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CE6FC9-BC4E-4F2A-9D92-3E644FC513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AAA503-ADEB-4670-87BA-16003AD211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3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marL="298440" indent="-29844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47640" indent="-24912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995400" indent="-19836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393920" indent="-19836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792440" indent="-19872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792440" indent="-19872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792440" indent="-19872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64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64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64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Autofit/>
          </a:bodyPr>
          <a:lstStyle>
            <a:lvl1pPr indent="0" algn="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fld id="{41FC8A5E-4D80-47FF-A8D1-CB7CA6CD6B12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535040" y="2550960"/>
            <a:ext cx="45230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535040" y="2432160"/>
            <a:ext cx="0" cy="239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495520" y="2432160"/>
            <a:ext cx="0" cy="239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398760" y="2432160"/>
            <a:ext cx="0" cy="239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4132440" y="2432160"/>
            <a:ext cx="0" cy="239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083600" y="1622520"/>
            <a:ext cx="871560" cy="445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9560" rIns="79560" tIns="39960" bIns="39960" anchor="t">
            <a:spAutoFit/>
          </a:bodyPr>
          <a:p>
            <a:pPr algn="ctr"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ITD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AML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978920" y="1622520"/>
            <a:ext cx="1904760" cy="262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9560" rIns="79560" tIns="39960" bIns="39960" anchor="t">
            <a:spAutoFit/>
          </a:bodyPr>
          <a:p>
            <a:pPr algn="ctr"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Induction/Consolid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4406040" y="1631880"/>
            <a:ext cx="379440" cy="262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9560" rIns="79560" tIns="39960" bIns="39960" anchor="t">
            <a:spAutoFit/>
          </a:bodyPr>
          <a:p>
            <a:pPr algn="ctr"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5205960" y="1619280"/>
            <a:ext cx="746640" cy="445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9560" rIns="79560" tIns="39960" bIns="39960" anchor="t">
            <a:spAutoFit/>
          </a:bodyPr>
          <a:p>
            <a:pPr algn="ctr"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Relap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689040" y="2787480"/>
            <a:ext cx="1841400" cy="2270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79560" rIns="79560" tIns="39960" bIns="39960" anchor="t">
            <a:spAutoFit/>
          </a:bodyPr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recursor mDCs,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DCs, mDC/pDC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erminal mDCs,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DC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R: IL-10,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tress cytoki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R: IL-10,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tress cytoki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4470480" y="2432160"/>
            <a:ext cx="0" cy="239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5210280" y="2432160"/>
            <a:ext cx="0" cy="239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423800" y="2085840"/>
            <a:ext cx="27252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9560" rIns="79560" tIns="39960" bIns="39960" anchor="t">
            <a:spAutoFit/>
          </a:bodyPr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328480" y="2070000"/>
            <a:ext cx="27252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9560" rIns="79560" tIns="39960" bIns="39960" anchor="t">
            <a:spAutoFit/>
          </a:bodyPr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3288960" y="2070000"/>
            <a:ext cx="27252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9560" rIns="79560" tIns="39960" bIns="39960" anchor="t">
            <a:spAutoFit/>
          </a:bodyPr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4000320" y="2070000"/>
            <a:ext cx="27252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9560" rIns="79560" tIns="39960" bIns="39960" anchor="t">
            <a:spAutoFit/>
          </a:bodyPr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9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4315680" y="2070000"/>
            <a:ext cx="38556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9560" rIns="79560" tIns="39960" bIns="39960" anchor="t">
            <a:spAutoFit/>
          </a:bodyPr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 flipV="1">
            <a:off x="2349360" y="2849400"/>
            <a:ext cx="0" cy="138240"/>
          </a:xfrm>
          <a:prstGeom prst="line">
            <a:avLst/>
          </a:prstGeom>
          <a:ln w="572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2349360" y="3417840"/>
            <a:ext cx="0" cy="138240"/>
          </a:xfrm>
          <a:prstGeom prst="line">
            <a:avLst/>
          </a:prstGeom>
          <a:ln w="572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flipV="1">
            <a:off x="2349360" y="3929040"/>
            <a:ext cx="0" cy="138240"/>
          </a:xfrm>
          <a:prstGeom prst="line">
            <a:avLst/>
          </a:prstGeom>
          <a:ln w="572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2569680" y="2789280"/>
            <a:ext cx="1263240" cy="13579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79560" rIns="79560" tIns="39960" bIns="39960" anchor="t">
            <a:spAutoFit/>
          </a:bodyPr>
          <a:p>
            <a:pPr algn="ctr"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Cs normalize,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IL-10, stres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ytoki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ormaliz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4676040" y="2085840"/>
            <a:ext cx="38556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9560" rIns="79560" tIns="39960" bIns="39960" anchor="t">
            <a:spAutoFit/>
          </a:bodyPr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4826160" y="2440080"/>
            <a:ext cx="0" cy="239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5910120" y="2440080"/>
            <a:ext cx="0" cy="239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5761800" y="2085840"/>
            <a:ext cx="38556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9560" rIns="79560" tIns="39960" bIns="39960" anchor="t">
            <a:spAutoFit/>
          </a:bodyPr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3868560" y="2789280"/>
            <a:ext cx="2041560" cy="1905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79560" rIns="79560" tIns="39960" bIns="39960" anchor="t">
            <a:spAutoFit/>
          </a:bodyPr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recursor mDC/ pD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erminal mDC1, mDC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R/REL: IL-10,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tress cytoki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months prior to relapse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  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5734080" y="3417840"/>
            <a:ext cx="0" cy="138240"/>
          </a:xfrm>
          <a:prstGeom prst="line">
            <a:avLst/>
          </a:prstGeom>
          <a:ln w="572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5060160" y="2085840"/>
            <a:ext cx="38556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9560" rIns="79560" tIns="39960" bIns="39960" anchor="t">
            <a:spAutoFit/>
          </a:bodyPr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8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 flipV="1">
            <a:off x="5734080" y="2849400"/>
            <a:ext cx="0" cy="138240"/>
          </a:xfrm>
          <a:prstGeom prst="line">
            <a:avLst/>
          </a:prstGeom>
          <a:ln w="572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1189080" y="2050920"/>
            <a:ext cx="701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2144880" y="2050920"/>
            <a:ext cx="15951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3995640" y="2050920"/>
            <a:ext cx="10224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5145120" y="2050920"/>
            <a:ext cx="10206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2349360" y="4503600"/>
            <a:ext cx="0" cy="139680"/>
          </a:xfrm>
          <a:prstGeom prst="line">
            <a:avLst/>
          </a:prstGeom>
          <a:ln w="572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 flipV="1">
            <a:off x="5734080" y="3835440"/>
            <a:ext cx="0" cy="139680"/>
          </a:xfrm>
          <a:prstGeom prst="line">
            <a:avLst/>
          </a:prstGeom>
          <a:ln w="572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404640" y="179280"/>
            <a:ext cx="5256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uppl. Fig 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07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01T11:41:00Z</dcterms:created>
  <dc:creator>rickmann</dc:creator>
  <dc:description/>
  <dc:language>en-US</dc:language>
  <cp:lastModifiedBy>rickmann</cp:lastModifiedBy>
  <dcterms:modified xsi:type="dcterms:W3CDTF">2013-02-15T11:14:15Z</dcterms:modified>
  <cp:revision>462</cp:revision>
  <dc:subject/>
  <dc:title>Slide 1</dc:title>
</cp:coreProperties>
</file>